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70" r:id="rId2"/>
    <p:sldId id="276" r:id="rId3"/>
    <p:sldId id="278" r:id="rId4"/>
  </p:sldIdLst>
  <p:sldSz cx="7920038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B388109-60A8-F607-EF32-8291E5384972}" name="Satoshi KURITA" initials="SK" userId="Satoshi KURITA" providerId="None"/>
  <p188:author id="{86E79C24-A3E9-AC8B-DFEE-B40A5124414B}" name="Satoshi Kurita" initials="SK" userId="Satoshi Kurita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406" autoAdjust="0"/>
    <p:restoredTop sz="94660"/>
  </p:normalViewPr>
  <p:slideViewPr>
    <p:cSldViewPr snapToGrid="0">
      <p:cViewPr varScale="1">
        <p:scale>
          <a:sx n="82" d="100"/>
          <a:sy n="82" d="100"/>
        </p:scale>
        <p:origin x="179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toshi%20KURITA\Box\&#9679;&#20027;&#35251;&#30340;&#35352;&#25014;&#20302;&#19979;&#12392;&#36939;&#36578;&#20107;&#25925;\&#12304;&#35299;&#26512;&#12305;SMC&#12392;&#20107;&#25925;2023.10.27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toshi%20KURITA\Box\&#9679;&#20027;&#35251;&#30340;&#35352;&#25014;&#20302;&#19979;&#12392;&#36939;&#36578;&#20107;&#25925;\&#12304;&#35299;&#26512;&#12305;SMC&#12392;&#20107;&#25925;2023.10.27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toshi%20KURITA\Box\&#9679;&#20027;&#35251;&#30340;&#35352;&#25014;&#20302;&#19979;&#12392;&#36939;&#36578;&#20107;&#25925;\&#12304;&#35299;&#26512;&#12305;SMC&#12392;&#20107;&#25925;2023.10.27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toshi%20KURITA\Box\&#9679;&#20027;&#35251;&#30340;&#35352;&#25014;&#20302;&#19979;&#12392;&#36939;&#36578;&#20107;&#25925;\&#12304;&#35299;&#26512;&#12305;SMC&#12392;&#20107;&#25925;2023.10.27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toshi%20KURITA\Box\&#9679;&#20027;&#35251;&#30340;&#35352;&#25014;&#20302;&#19979;&#12392;&#36939;&#36578;&#20107;&#25925;\&#12304;&#35299;&#26512;&#12305;SMC&#12392;&#20107;&#25925;2023.10.27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toshi%20KURITA\Box\&#9679;&#20027;&#35251;&#30340;&#35352;&#25014;&#20302;&#19979;&#12392;&#36939;&#36578;&#20107;&#25925;\&#12304;&#35299;&#26512;&#12305;SMC&#12392;&#20107;&#25925;2023.10.27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toshi%20KURITA\Box\&#9679;&#20027;&#35251;&#30340;&#35352;&#25014;&#20302;&#19979;&#12392;&#36939;&#36578;&#20107;&#25925;\&#12304;&#35299;&#26512;&#12305;SMC&#12392;&#20107;&#25925;2023.10.27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toshi%20KURITA\Box\&#9679;&#20027;&#35251;&#30340;&#35352;&#25014;&#20302;&#19979;&#12392;&#36939;&#36578;&#20107;&#25925;\&#12304;&#35299;&#26512;&#12305;SMC&#12392;&#20107;&#25925;2023.10.27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toshi%20KURITA\Box\&#9679;&#20027;&#35251;&#30340;&#35352;&#25014;&#20302;&#19979;&#12392;&#36939;&#36578;&#20107;&#25925;\&#12304;&#35299;&#26512;&#12305;SMC&#12392;&#20107;&#25925;2023.10.27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toshi%20KURITA\Box\&#9679;&#20027;&#35251;&#30340;&#35352;&#25014;&#20302;&#19979;&#12392;&#36939;&#36578;&#20107;&#25925;\&#12304;&#35299;&#26512;&#12305;SMC&#12392;&#20107;&#25925;2023.10.27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toshi%20KURITA\Box\&#9679;&#20027;&#35251;&#30340;&#35352;&#25014;&#20302;&#19979;&#12392;&#36939;&#36578;&#20107;&#25925;\&#12304;&#35299;&#26512;&#12305;SMC&#12392;&#20107;&#25925;2023.10.27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atoshi%20KURITA\Box\&#9679;&#20027;&#35251;&#30340;&#35352;&#25014;&#20302;&#19979;&#12392;&#36939;&#36578;&#20107;&#25925;\&#12304;&#35299;&#26512;&#12305;SMC&#12392;&#20107;&#25925;2023.10.27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主観的記憶低下とアウトカムの分布!$J$21</c:f>
              <c:strCache>
                <c:ptCount val="1"/>
                <c:pt idx="0">
                  <c:v>ヒヤリハット経験あり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主観的記憶低下とアウトカムの分布!$I$55:$I$60</c:f>
              <c:strCache>
                <c:ptCount val="6"/>
                <c:pt idx="0">
                  <c:v>0 item
n = 4635</c:v>
                </c:pt>
                <c:pt idx="1">
                  <c:v>1 item
n = 3487</c:v>
                </c:pt>
                <c:pt idx="2">
                  <c:v>2 items
n = 2431</c:v>
                </c:pt>
                <c:pt idx="3">
                  <c:v>3 items
n = 1555</c:v>
                </c:pt>
                <c:pt idx="4">
                  <c:v>4 items
n = 807</c:v>
                </c:pt>
                <c:pt idx="5">
                  <c:v>5 items
n = 222</c:v>
                </c:pt>
              </c:strCache>
            </c:strRef>
          </c:cat>
          <c:val>
            <c:numRef>
              <c:f>主観的記憶低下とアウトカムの分布!$J$55:$J$60</c:f>
              <c:numCache>
                <c:formatCode>###0.0%</c:formatCode>
                <c:ptCount val="6"/>
                <c:pt idx="0">
                  <c:v>0.13376483279395901</c:v>
                </c:pt>
                <c:pt idx="1">
                  <c:v>0.17350157728706622</c:v>
                </c:pt>
                <c:pt idx="2">
                  <c:v>0.21020156314273961</c:v>
                </c:pt>
                <c:pt idx="3">
                  <c:v>0.23279742765273312</c:v>
                </c:pt>
                <c:pt idx="4">
                  <c:v>0.28376703841387857</c:v>
                </c:pt>
                <c:pt idx="5">
                  <c:v>0.37837837837837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303-4A69-A356-5FD6348B46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558688"/>
        <c:axId val="296098928"/>
      </c:barChart>
      <c:catAx>
        <c:axId val="29955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6098928"/>
        <c:crosses val="autoZero"/>
        <c:auto val="1"/>
        <c:lblAlgn val="ctr"/>
        <c:lblOffset val="100"/>
        <c:noMultiLvlLbl val="0"/>
      </c:catAx>
      <c:valAx>
        <c:axId val="2960989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955868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主観的記憶低下とアウトカムの分布!$J$21</c:f>
              <c:strCache>
                <c:ptCount val="1"/>
                <c:pt idx="0">
                  <c:v>ヒヤリハット経験あり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主観的記憶低下とアウトカムの分布!$I$217:$I$222</c:f>
              <c:strCache>
                <c:ptCount val="6"/>
                <c:pt idx="0">
                  <c:v>0 item</c:v>
                </c:pt>
                <c:pt idx="1">
                  <c:v>1 item</c:v>
                </c:pt>
                <c:pt idx="2">
                  <c:v>2 items</c:v>
                </c:pt>
                <c:pt idx="3">
                  <c:v>3 items</c:v>
                </c:pt>
                <c:pt idx="4">
                  <c:v>4 items</c:v>
                </c:pt>
                <c:pt idx="5">
                  <c:v>5 items</c:v>
                </c:pt>
              </c:strCache>
            </c:strRef>
          </c:cat>
          <c:val>
            <c:numRef>
              <c:f>主観的記憶低下とアウトカムの分布!$J$217:$J$222</c:f>
              <c:numCache>
                <c:formatCode>###0.0%</c:formatCode>
                <c:ptCount val="6"/>
                <c:pt idx="0">
                  <c:v>3.4519956850053938E-3</c:v>
                </c:pt>
                <c:pt idx="1">
                  <c:v>6.0223687983940351E-3</c:v>
                </c:pt>
                <c:pt idx="2">
                  <c:v>1.0283833813245578E-2</c:v>
                </c:pt>
                <c:pt idx="3">
                  <c:v>1.2861736334405145E-2</c:v>
                </c:pt>
                <c:pt idx="4">
                  <c:v>2.3543990086741014E-2</c:v>
                </c:pt>
                <c:pt idx="5">
                  <c:v>3.153153153153152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E3-49FD-90B2-56BD73ED0C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558688"/>
        <c:axId val="296098928"/>
      </c:barChart>
      <c:catAx>
        <c:axId val="29955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6098928"/>
        <c:crosses val="autoZero"/>
        <c:auto val="1"/>
        <c:lblAlgn val="ctr"/>
        <c:lblOffset val="100"/>
        <c:noMultiLvlLbl val="0"/>
      </c:catAx>
      <c:valAx>
        <c:axId val="296098928"/>
        <c:scaling>
          <c:orientation val="minMax"/>
          <c:max val="4.0000000000000008E-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9558688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主観的記憶低下とアウトカムの分布!$J$21</c:f>
              <c:strCache>
                <c:ptCount val="1"/>
                <c:pt idx="0">
                  <c:v>ヒヤリハット経験あり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主観的記憶低下とアウトカムの分布!$I$235:$I$240</c:f>
              <c:strCache>
                <c:ptCount val="6"/>
                <c:pt idx="0">
                  <c:v>0 item</c:v>
                </c:pt>
                <c:pt idx="1">
                  <c:v>1 item</c:v>
                </c:pt>
                <c:pt idx="2">
                  <c:v>2 items</c:v>
                </c:pt>
                <c:pt idx="3">
                  <c:v>3 items</c:v>
                </c:pt>
                <c:pt idx="4">
                  <c:v>4 items</c:v>
                </c:pt>
                <c:pt idx="5">
                  <c:v>5 items</c:v>
                </c:pt>
              </c:strCache>
            </c:strRef>
          </c:cat>
          <c:val>
            <c:numRef>
              <c:f>主観的記憶低下とアウトカムの分布!$J$235:$J$240</c:f>
              <c:numCache>
                <c:formatCode>###0.0%</c:formatCode>
                <c:ptCount val="6"/>
                <c:pt idx="0">
                  <c:v>0.13484358144552319</c:v>
                </c:pt>
                <c:pt idx="1">
                  <c:v>0.19787783194723257</c:v>
                </c:pt>
                <c:pt idx="2">
                  <c:v>0.25215960510078156</c:v>
                </c:pt>
                <c:pt idx="3">
                  <c:v>0.28167202572347266</c:v>
                </c:pt>
                <c:pt idx="4">
                  <c:v>0.32589838909541513</c:v>
                </c:pt>
                <c:pt idx="5">
                  <c:v>0.436936936936936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F15-4592-96FC-DE0FBD6A1E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558688"/>
        <c:axId val="296098928"/>
      </c:barChart>
      <c:catAx>
        <c:axId val="29955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6098928"/>
        <c:crosses val="autoZero"/>
        <c:auto val="1"/>
        <c:lblAlgn val="ctr"/>
        <c:lblOffset val="100"/>
        <c:noMultiLvlLbl val="0"/>
      </c:catAx>
      <c:valAx>
        <c:axId val="2960989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955868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主観的記憶低下とアウトカムの分布!$J$21</c:f>
              <c:strCache>
                <c:ptCount val="1"/>
                <c:pt idx="0">
                  <c:v>ヒヤリハット経験あり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主観的記憶低下とアウトカムの分布!$I$253:$I$258</c:f>
              <c:strCache>
                <c:ptCount val="6"/>
                <c:pt idx="0">
                  <c:v>0 item</c:v>
                </c:pt>
                <c:pt idx="1">
                  <c:v>1 item</c:v>
                </c:pt>
                <c:pt idx="2">
                  <c:v>2 items</c:v>
                </c:pt>
                <c:pt idx="3">
                  <c:v>3 items</c:v>
                </c:pt>
                <c:pt idx="4">
                  <c:v>4 items</c:v>
                </c:pt>
                <c:pt idx="5">
                  <c:v>5 items</c:v>
                </c:pt>
              </c:strCache>
            </c:strRef>
          </c:cat>
          <c:val>
            <c:numRef>
              <c:f>主観的記憶低下とアウトカムの分布!$J$253:$J$258</c:f>
              <c:numCache>
                <c:formatCode>###0.0%</c:formatCode>
                <c:ptCount val="6"/>
                <c:pt idx="0">
                  <c:v>0.12125134843581446</c:v>
                </c:pt>
                <c:pt idx="1">
                  <c:v>0.17608259248637798</c:v>
                </c:pt>
                <c:pt idx="2">
                  <c:v>0.22254216371863433</c:v>
                </c:pt>
                <c:pt idx="3">
                  <c:v>0.23344051446945341</c:v>
                </c:pt>
                <c:pt idx="4">
                  <c:v>0.34076827757125161</c:v>
                </c:pt>
                <c:pt idx="5">
                  <c:v>0.36036036036036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207-416D-A44D-4DE55D8C8F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558688"/>
        <c:axId val="296098928"/>
      </c:barChart>
      <c:catAx>
        <c:axId val="29955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6098928"/>
        <c:crosses val="autoZero"/>
        <c:auto val="1"/>
        <c:lblAlgn val="ctr"/>
        <c:lblOffset val="100"/>
        <c:noMultiLvlLbl val="0"/>
      </c:catAx>
      <c:valAx>
        <c:axId val="2960989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955868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主観的記憶低下とアウトカムの分布!$J$21</c:f>
              <c:strCache>
                <c:ptCount val="1"/>
                <c:pt idx="0">
                  <c:v>ヒヤリハット経験あり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主観的記憶低下とアウトカムの分布!$I$73:$I$78</c:f>
              <c:strCache>
                <c:ptCount val="6"/>
                <c:pt idx="0">
                  <c:v>0 item</c:v>
                </c:pt>
                <c:pt idx="1">
                  <c:v>1 item</c:v>
                </c:pt>
                <c:pt idx="2">
                  <c:v>2 items</c:v>
                </c:pt>
                <c:pt idx="3">
                  <c:v>3 items</c:v>
                </c:pt>
                <c:pt idx="4">
                  <c:v>4 items</c:v>
                </c:pt>
                <c:pt idx="5">
                  <c:v>5 items</c:v>
                </c:pt>
              </c:strCache>
            </c:strRef>
          </c:cat>
          <c:val>
            <c:numRef>
              <c:f>主観的記憶低下とアウトカムの分布!$J$73:$J$78</c:f>
              <c:numCache>
                <c:formatCode>###0.0%</c:formatCode>
                <c:ptCount val="6"/>
                <c:pt idx="0">
                  <c:v>5.1564185544768069E-2</c:v>
                </c:pt>
                <c:pt idx="1">
                  <c:v>7.3415543447089185E-2</c:v>
                </c:pt>
                <c:pt idx="2">
                  <c:v>8.9675030851501442E-2</c:v>
                </c:pt>
                <c:pt idx="3">
                  <c:v>9.5819935691318345E-2</c:v>
                </c:pt>
                <c:pt idx="4">
                  <c:v>0.13135068153655513</c:v>
                </c:pt>
                <c:pt idx="5">
                  <c:v>0.19819819819819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4CA-40A0-9842-D6CEA93A07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558688"/>
        <c:axId val="296098928"/>
      </c:barChart>
      <c:catAx>
        <c:axId val="29955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6098928"/>
        <c:crosses val="autoZero"/>
        <c:auto val="1"/>
        <c:lblAlgn val="ctr"/>
        <c:lblOffset val="100"/>
        <c:noMultiLvlLbl val="0"/>
      </c:catAx>
      <c:valAx>
        <c:axId val="2960989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9558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主観的記憶低下とアウトカムの分布!$J$21</c:f>
              <c:strCache>
                <c:ptCount val="1"/>
                <c:pt idx="0">
                  <c:v>ヒヤリハット経験あり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主観的記憶低下とアウトカムの分布!$I$91:$I$96</c:f>
              <c:strCache>
                <c:ptCount val="6"/>
                <c:pt idx="0">
                  <c:v>0 item</c:v>
                </c:pt>
                <c:pt idx="1">
                  <c:v>1 item</c:v>
                </c:pt>
                <c:pt idx="2">
                  <c:v>2 items</c:v>
                </c:pt>
                <c:pt idx="3">
                  <c:v>3 items</c:v>
                </c:pt>
                <c:pt idx="4">
                  <c:v>4 items</c:v>
                </c:pt>
                <c:pt idx="5">
                  <c:v>5 items</c:v>
                </c:pt>
              </c:strCache>
            </c:strRef>
          </c:cat>
          <c:val>
            <c:numRef>
              <c:f>主観的記憶低下とアウトカムの分布!$J$91:$J$96</c:f>
              <c:numCache>
                <c:formatCode>###0.0%</c:formatCode>
                <c:ptCount val="6"/>
                <c:pt idx="0">
                  <c:v>9.320388349514562E-2</c:v>
                </c:pt>
                <c:pt idx="1">
                  <c:v>0.13220533409807858</c:v>
                </c:pt>
                <c:pt idx="2">
                  <c:v>0.1476758535582065</c:v>
                </c:pt>
                <c:pt idx="3">
                  <c:v>0.16784565916398711</c:v>
                </c:pt>
                <c:pt idx="4">
                  <c:v>0.23791821561338289</c:v>
                </c:pt>
                <c:pt idx="5">
                  <c:v>0.238738738738738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96-4D49-BB51-592F1C1F65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558688"/>
        <c:axId val="296098928"/>
      </c:barChart>
      <c:catAx>
        <c:axId val="29955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6098928"/>
        <c:crosses val="autoZero"/>
        <c:auto val="1"/>
        <c:lblAlgn val="ctr"/>
        <c:lblOffset val="100"/>
        <c:noMultiLvlLbl val="0"/>
      </c:catAx>
      <c:valAx>
        <c:axId val="2960989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9558688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主観的記憶低下とアウトカムの分布!$J$21</c:f>
              <c:strCache>
                <c:ptCount val="1"/>
                <c:pt idx="0">
                  <c:v>ヒヤリハット経験あり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主観的記憶低下とアウトカムの分布!$I$109:$I$114</c:f>
              <c:strCache>
                <c:ptCount val="6"/>
                <c:pt idx="0">
                  <c:v>0 item</c:v>
                </c:pt>
                <c:pt idx="1">
                  <c:v>1 item</c:v>
                </c:pt>
                <c:pt idx="2">
                  <c:v>2 items</c:v>
                </c:pt>
                <c:pt idx="3">
                  <c:v>3 items</c:v>
                </c:pt>
                <c:pt idx="4">
                  <c:v>4 items</c:v>
                </c:pt>
                <c:pt idx="5">
                  <c:v>5 items</c:v>
                </c:pt>
              </c:strCache>
            </c:strRef>
          </c:cat>
          <c:val>
            <c:numRef>
              <c:f>主観的記憶低下とアウトカムの分布!$J$109:$J$114</c:f>
              <c:numCache>
                <c:formatCode>###0.0%</c:formatCode>
                <c:ptCount val="6"/>
                <c:pt idx="0">
                  <c:v>8.8888888888888892E-2</c:v>
                </c:pt>
                <c:pt idx="1">
                  <c:v>0.11987381703470032</c:v>
                </c:pt>
                <c:pt idx="2">
                  <c:v>0.13780337309749074</c:v>
                </c:pt>
                <c:pt idx="3">
                  <c:v>0.16077170418006431</c:v>
                </c:pt>
                <c:pt idx="4">
                  <c:v>0.21189591078066916</c:v>
                </c:pt>
                <c:pt idx="5">
                  <c:v>0.238738738738738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CD-4CC6-AF04-CB0A6E807F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558688"/>
        <c:axId val="296098928"/>
      </c:barChart>
      <c:catAx>
        <c:axId val="29955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6098928"/>
        <c:crosses val="autoZero"/>
        <c:auto val="1"/>
        <c:lblAlgn val="ctr"/>
        <c:lblOffset val="100"/>
        <c:noMultiLvlLbl val="0"/>
      </c:catAx>
      <c:valAx>
        <c:axId val="2960989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9558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主観的記憶低下とアウトカムの分布!$J$21</c:f>
              <c:strCache>
                <c:ptCount val="1"/>
                <c:pt idx="0">
                  <c:v>ヒヤリハット経験あり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主観的記憶低下とアウトカムの分布!$I$127:$I$132</c:f>
              <c:strCache>
                <c:ptCount val="6"/>
                <c:pt idx="0">
                  <c:v>0 item</c:v>
                </c:pt>
                <c:pt idx="1">
                  <c:v>1 item</c:v>
                </c:pt>
                <c:pt idx="2">
                  <c:v>2 items</c:v>
                </c:pt>
                <c:pt idx="3">
                  <c:v>3 items</c:v>
                </c:pt>
                <c:pt idx="4">
                  <c:v>4 items</c:v>
                </c:pt>
                <c:pt idx="5">
                  <c:v>5 items</c:v>
                </c:pt>
              </c:strCache>
            </c:strRef>
          </c:cat>
          <c:val>
            <c:numRef>
              <c:f>主観的記憶低下とアウトカムの分布!$J$127:$J$132</c:f>
              <c:numCache>
                <c:formatCode>###0.0%</c:formatCode>
                <c:ptCount val="6"/>
                <c:pt idx="0">
                  <c:v>5.1779935275080898E-3</c:v>
                </c:pt>
                <c:pt idx="1">
                  <c:v>5.7355893318038432E-3</c:v>
                </c:pt>
                <c:pt idx="2">
                  <c:v>1.1929247223364869E-2</c:v>
                </c:pt>
                <c:pt idx="3">
                  <c:v>1.2218649517684888E-2</c:v>
                </c:pt>
                <c:pt idx="4">
                  <c:v>8.6741016109045856E-3</c:v>
                </c:pt>
                <c:pt idx="5">
                  <c:v>3.153153153153152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0C-4B60-97BE-FF5A0250A4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558688"/>
        <c:axId val="296098928"/>
      </c:barChart>
      <c:catAx>
        <c:axId val="29955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6098928"/>
        <c:crosses val="autoZero"/>
        <c:auto val="1"/>
        <c:lblAlgn val="ctr"/>
        <c:lblOffset val="100"/>
        <c:noMultiLvlLbl val="0"/>
      </c:catAx>
      <c:valAx>
        <c:axId val="2960989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99558688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主観的記憶低下とアウトカムの分布!$J$21</c:f>
              <c:strCache>
                <c:ptCount val="1"/>
                <c:pt idx="0">
                  <c:v>ヒヤリハット経験あり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主観的記憶低下とアウトカムの分布!$I$145:$I$150</c:f>
              <c:strCache>
                <c:ptCount val="6"/>
                <c:pt idx="0">
                  <c:v>0 item</c:v>
                </c:pt>
                <c:pt idx="1">
                  <c:v>1 item</c:v>
                </c:pt>
                <c:pt idx="2">
                  <c:v>2 items</c:v>
                </c:pt>
                <c:pt idx="3">
                  <c:v>3 items</c:v>
                </c:pt>
                <c:pt idx="4">
                  <c:v>4 items</c:v>
                </c:pt>
                <c:pt idx="5">
                  <c:v>5 items</c:v>
                </c:pt>
              </c:strCache>
            </c:strRef>
          </c:cat>
          <c:val>
            <c:numRef>
              <c:f>主観的記憶低下とアウトカムの分布!$J$145:$J$150</c:f>
              <c:numCache>
                <c:formatCode>###0.0%</c:formatCode>
                <c:ptCount val="6"/>
                <c:pt idx="0">
                  <c:v>4.3149946062567418E-2</c:v>
                </c:pt>
                <c:pt idx="1">
                  <c:v>8.0298250645253796E-2</c:v>
                </c:pt>
                <c:pt idx="2">
                  <c:v>9.1320444261620726E-2</c:v>
                </c:pt>
                <c:pt idx="3">
                  <c:v>0.1080385852090032</c:v>
                </c:pt>
                <c:pt idx="4">
                  <c:v>0.14250309789343246</c:v>
                </c:pt>
                <c:pt idx="5">
                  <c:v>0.193693693693693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62-4640-AFA0-0873063996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558688"/>
        <c:axId val="296098928"/>
      </c:barChart>
      <c:catAx>
        <c:axId val="29955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6098928"/>
        <c:crosses val="autoZero"/>
        <c:auto val="1"/>
        <c:lblAlgn val="ctr"/>
        <c:lblOffset val="100"/>
        <c:noMultiLvlLbl val="0"/>
      </c:catAx>
      <c:valAx>
        <c:axId val="296098928"/>
        <c:scaling>
          <c:orientation val="minMax"/>
          <c:max val="0.2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9558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主観的記憶低下とアウトカムの分布!$J$21</c:f>
              <c:strCache>
                <c:ptCount val="1"/>
                <c:pt idx="0">
                  <c:v>ヒヤリハット経験あり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主観的記憶低下とアウトカムの分布!$I$163:$I$168</c:f>
              <c:strCache>
                <c:ptCount val="6"/>
                <c:pt idx="0">
                  <c:v>0 item</c:v>
                </c:pt>
                <c:pt idx="1">
                  <c:v>1 item</c:v>
                </c:pt>
                <c:pt idx="2">
                  <c:v>2 items</c:v>
                </c:pt>
                <c:pt idx="3">
                  <c:v>3 items</c:v>
                </c:pt>
                <c:pt idx="4">
                  <c:v>4 items</c:v>
                </c:pt>
                <c:pt idx="5">
                  <c:v>5 items</c:v>
                </c:pt>
              </c:strCache>
            </c:strRef>
          </c:cat>
          <c:val>
            <c:numRef>
              <c:f>主観的記憶低下とアウトカムの分布!$J$163:$J$168</c:f>
              <c:numCache>
                <c:formatCode>###0.0%</c:formatCode>
                <c:ptCount val="6"/>
                <c:pt idx="0">
                  <c:v>5.5016181229773461E-2</c:v>
                </c:pt>
                <c:pt idx="1">
                  <c:v>7.8864353312302835E-2</c:v>
                </c:pt>
                <c:pt idx="2">
                  <c:v>9.3377211024269838E-2</c:v>
                </c:pt>
                <c:pt idx="3">
                  <c:v>0.12282958199356914</c:v>
                </c:pt>
                <c:pt idx="4">
                  <c:v>0.14002478314745972</c:v>
                </c:pt>
                <c:pt idx="5">
                  <c:v>0.193693693693693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BA-482C-954B-3CFB554973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558688"/>
        <c:axId val="296098928"/>
      </c:barChart>
      <c:catAx>
        <c:axId val="29955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6098928"/>
        <c:crosses val="autoZero"/>
        <c:auto val="1"/>
        <c:lblAlgn val="ctr"/>
        <c:lblOffset val="100"/>
        <c:noMultiLvlLbl val="0"/>
      </c:catAx>
      <c:valAx>
        <c:axId val="296098928"/>
        <c:scaling>
          <c:orientation val="minMax"/>
          <c:max val="0.2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9558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主観的記憶低下とアウトカムの分布!$J$21</c:f>
              <c:strCache>
                <c:ptCount val="1"/>
                <c:pt idx="0">
                  <c:v>ヒヤリハット経験あり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主観的記憶低下とアウトカムの分布!$I$181:$I$186</c:f>
              <c:strCache>
                <c:ptCount val="6"/>
                <c:pt idx="0">
                  <c:v>0 item</c:v>
                </c:pt>
                <c:pt idx="1">
                  <c:v>1 item</c:v>
                </c:pt>
                <c:pt idx="2">
                  <c:v>2 items</c:v>
                </c:pt>
                <c:pt idx="3">
                  <c:v>3 items</c:v>
                </c:pt>
                <c:pt idx="4">
                  <c:v>4 items</c:v>
                </c:pt>
                <c:pt idx="5">
                  <c:v>5 items</c:v>
                </c:pt>
              </c:strCache>
            </c:strRef>
          </c:cat>
          <c:val>
            <c:numRef>
              <c:f>主観的記憶低下とアウトカムの分布!$J$181:$J$186</c:f>
              <c:numCache>
                <c:formatCode>###0.0%</c:formatCode>
                <c:ptCount val="6"/>
                <c:pt idx="0">
                  <c:v>4.4228694714131607E-2</c:v>
                </c:pt>
                <c:pt idx="1">
                  <c:v>5.8216231717809007E-2</c:v>
                </c:pt>
                <c:pt idx="2">
                  <c:v>7.1575483340189219E-2</c:v>
                </c:pt>
                <c:pt idx="3">
                  <c:v>9.0032154340836015E-2</c:v>
                </c:pt>
                <c:pt idx="4">
                  <c:v>0.13135068153655513</c:v>
                </c:pt>
                <c:pt idx="5">
                  <c:v>0.153153153153153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7F-4488-972B-C3BB0C19A8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558688"/>
        <c:axId val="296098928"/>
      </c:barChart>
      <c:catAx>
        <c:axId val="29955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6098928"/>
        <c:crosses val="autoZero"/>
        <c:auto val="1"/>
        <c:lblAlgn val="ctr"/>
        <c:lblOffset val="100"/>
        <c:noMultiLvlLbl val="0"/>
      </c:catAx>
      <c:valAx>
        <c:axId val="296098928"/>
        <c:scaling>
          <c:orientation val="minMax"/>
          <c:max val="0.2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9558688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主観的記憶低下とアウトカムの分布!$J$21</c:f>
              <c:strCache>
                <c:ptCount val="1"/>
                <c:pt idx="0">
                  <c:v>ヒヤリハット経験あり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主観的記憶低下とアウトカムの分布!$I$199:$I$204</c:f>
              <c:strCache>
                <c:ptCount val="6"/>
                <c:pt idx="0">
                  <c:v>0 item</c:v>
                </c:pt>
                <c:pt idx="1">
                  <c:v>1 item</c:v>
                </c:pt>
                <c:pt idx="2">
                  <c:v>2 items</c:v>
                </c:pt>
                <c:pt idx="3">
                  <c:v>3 items</c:v>
                </c:pt>
                <c:pt idx="4">
                  <c:v>4 items</c:v>
                </c:pt>
                <c:pt idx="5">
                  <c:v>5 items</c:v>
                </c:pt>
              </c:strCache>
            </c:strRef>
          </c:cat>
          <c:val>
            <c:numRef>
              <c:f>主観的記憶低下とアウトカムの分布!$J$199:$J$204</c:f>
              <c:numCache>
                <c:formatCode>###0.0%</c:formatCode>
                <c:ptCount val="6"/>
                <c:pt idx="0">
                  <c:v>1.3807982740021575E-2</c:v>
                </c:pt>
                <c:pt idx="1">
                  <c:v>2.667049039288787E-2</c:v>
                </c:pt>
                <c:pt idx="2">
                  <c:v>3.1674208144796379E-2</c:v>
                </c:pt>
                <c:pt idx="3">
                  <c:v>4.5016077170418008E-2</c:v>
                </c:pt>
                <c:pt idx="4">
                  <c:v>5.3283767038413886E-2</c:v>
                </c:pt>
                <c:pt idx="5">
                  <c:v>0.10810810810810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B2-47E3-8029-24A1B8F9D7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558688"/>
        <c:axId val="296098928"/>
      </c:barChart>
      <c:catAx>
        <c:axId val="299558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6098928"/>
        <c:crosses val="autoZero"/>
        <c:auto val="1"/>
        <c:lblAlgn val="ctr"/>
        <c:lblOffset val="100"/>
        <c:noMultiLvlLbl val="0"/>
      </c:catAx>
      <c:valAx>
        <c:axId val="296098928"/>
        <c:scaling>
          <c:orientation val="minMax"/>
          <c:max val="0.15000000000000002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%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99558688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4003" y="1767462"/>
            <a:ext cx="6732032" cy="3759917"/>
          </a:xfrm>
        </p:spPr>
        <p:txBody>
          <a:bodyPr anchor="b"/>
          <a:lstStyle>
            <a:lvl1pPr algn="ctr">
              <a:defRPr sz="519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5672376"/>
            <a:ext cx="5940029" cy="2607442"/>
          </a:xfrm>
        </p:spPr>
        <p:txBody>
          <a:bodyPr/>
          <a:lstStyle>
            <a:lvl1pPr marL="0" indent="0" algn="ctr">
              <a:buNone/>
              <a:defRPr sz="2079"/>
            </a:lvl1pPr>
            <a:lvl2pPr marL="395981" indent="0" algn="ctr">
              <a:buNone/>
              <a:defRPr sz="1732"/>
            </a:lvl2pPr>
            <a:lvl3pPr marL="791962" indent="0" algn="ctr">
              <a:buNone/>
              <a:defRPr sz="1559"/>
            </a:lvl3pPr>
            <a:lvl4pPr marL="1187943" indent="0" algn="ctr">
              <a:buNone/>
              <a:defRPr sz="1386"/>
            </a:lvl4pPr>
            <a:lvl5pPr marL="1583924" indent="0" algn="ctr">
              <a:buNone/>
              <a:defRPr sz="1386"/>
            </a:lvl5pPr>
            <a:lvl6pPr marL="1979905" indent="0" algn="ctr">
              <a:buNone/>
              <a:defRPr sz="1386"/>
            </a:lvl6pPr>
            <a:lvl7pPr marL="2375886" indent="0" algn="ctr">
              <a:buNone/>
              <a:defRPr sz="1386"/>
            </a:lvl7pPr>
            <a:lvl8pPr marL="2771866" indent="0" algn="ctr">
              <a:buNone/>
              <a:defRPr sz="1386"/>
            </a:lvl8pPr>
            <a:lvl9pPr marL="3167847" indent="0" algn="ctr">
              <a:buNone/>
              <a:defRPr sz="1386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1A41E-53F2-400E-ADFE-67706180A4D3}" type="datetimeFigureOut">
              <a:rPr kumimoji="1" lang="ja-JP" altLang="en-US" smtClean="0"/>
              <a:t>2024/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2ECE2-64B9-412A-81B2-A51B10537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8151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1A41E-53F2-400E-ADFE-67706180A4D3}" type="datetimeFigureOut">
              <a:rPr kumimoji="1" lang="ja-JP" altLang="en-US" smtClean="0"/>
              <a:t>2024/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2ECE2-64B9-412A-81B2-A51B10537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2854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8" y="574987"/>
            <a:ext cx="1707758" cy="91523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574987"/>
            <a:ext cx="5024274" cy="91523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1A41E-53F2-400E-ADFE-67706180A4D3}" type="datetimeFigureOut">
              <a:rPr kumimoji="1" lang="ja-JP" altLang="en-US" smtClean="0"/>
              <a:t>2024/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2ECE2-64B9-412A-81B2-A51B10537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2124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1A41E-53F2-400E-ADFE-67706180A4D3}" type="datetimeFigureOut">
              <a:rPr kumimoji="1" lang="ja-JP" altLang="en-US" smtClean="0"/>
              <a:t>2024/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2ECE2-64B9-412A-81B2-A51B10537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101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8" y="2692444"/>
            <a:ext cx="6831033" cy="4492401"/>
          </a:xfrm>
        </p:spPr>
        <p:txBody>
          <a:bodyPr anchor="b"/>
          <a:lstStyle>
            <a:lvl1pPr>
              <a:defRPr sz="519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8" y="7227345"/>
            <a:ext cx="6831033" cy="2362447"/>
          </a:xfrm>
        </p:spPr>
        <p:txBody>
          <a:bodyPr/>
          <a:lstStyle>
            <a:lvl1pPr marL="0" indent="0">
              <a:buNone/>
              <a:defRPr sz="2079">
                <a:solidFill>
                  <a:schemeClr val="tx1"/>
                </a:solidFill>
              </a:defRPr>
            </a:lvl1pPr>
            <a:lvl2pPr marL="395981" indent="0">
              <a:buNone/>
              <a:defRPr sz="1732">
                <a:solidFill>
                  <a:schemeClr val="tx1">
                    <a:tint val="75000"/>
                  </a:schemeClr>
                </a:solidFill>
              </a:defRPr>
            </a:lvl2pPr>
            <a:lvl3pPr marL="791962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3pPr>
            <a:lvl4pPr marL="1187943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4pPr>
            <a:lvl5pPr marL="1583924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5pPr>
            <a:lvl6pPr marL="1979905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6pPr>
            <a:lvl7pPr marL="237588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7pPr>
            <a:lvl8pPr marL="277186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8pPr>
            <a:lvl9pPr marL="3167847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1A41E-53F2-400E-ADFE-67706180A4D3}" type="datetimeFigureOut">
              <a:rPr kumimoji="1" lang="ja-JP" altLang="en-US" smtClean="0"/>
              <a:t>2024/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2ECE2-64B9-412A-81B2-A51B10537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173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2874937"/>
            <a:ext cx="3366016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2874937"/>
            <a:ext cx="3366016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1A41E-53F2-400E-ADFE-67706180A4D3}" type="datetimeFigureOut">
              <a:rPr kumimoji="1" lang="ja-JP" altLang="en-US" smtClean="0"/>
              <a:t>2024/3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2ECE2-64B9-412A-81B2-A51B10537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2180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574990"/>
            <a:ext cx="6831033" cy="208745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2647443"/>
            <a:ext cx="3350547" cy="1297471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3944914"/>
            <a:ext cx="3350547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20" y="2647443"/>
            <a:ext cx="3367048" cy="1297471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20" y="3944914"/>
            <a:ext cx="3367048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1A41E-53F2-400E-ADFE-67706180A4D3}" type="datetimeFigureOut">
              <a:rPr kumimoji="1" lang="ja-JP" altLang="en-US" smtClean="0"/>
              <a:t>2024/3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2ECE2-64B9-412A-81B2-A51B10537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1542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1A41E-53F2-400E-ADFE-67706180A4D3}" type="datetimeFigureOut">
              <a:rPr kumimoji="1" lang="ja-JP" altLang="en-US" smtClean="0"/>
              <a:t>2024/3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2ECE2-64B9-412A-81B2-A51B10537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9936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1A41E-53F2-400E-ADFE-67706180A4D3}" type="datetimeFigureOut">
              <a:rPr kumimoji="1" lang="ja-JP" altLang="en-US" smtClean="0"/>
              <a:t>2024/3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2ECE2-64B9-412A-81B2-A51B10537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8543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719984"/>
            <a:ext cx="2554418" cy="2519945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1554968"/>
            <a:ext cx="4009519" cy="7674832"/>
          </a:xfrm>
        </p:spPr>
        <p:txBody>
          <a:bodyPr/>
          <a:lstStyle>
            <a:lvl1pPr>
              <a:defRPr sz="2772"/>
            </a:lvl1pPr>
            <a:lvl2pPr>
              <a:defRPr sz="2425"/>
            </a:lvl2pPr>
            <a:lvl3pPr>
              <a:defRPr sz="2079"/>
            </a:lvl3pPr>
            <a:lvl4pPr>
              <a:defRPr sz="1732"/>
            </a:lvl4pPr>
            <a:lvl5pPr>
              <a:defRPr sz="1732"/>
            </a:lvl5pPr>
            <a:lvl6pPr>
              <a:defRPr sz="1732"/>
            </a:lvl6pPr>
            <a:lvl7pPr>
              <a:defRPr sz="1732"/>
            </a:lvl7pPr>
            <a:lvl8pPr>
              <a:defRPr sz="1732"/>
            </a:lvl8pPr>
            <a:lvl9pPr>
              <a:defRPr sz="173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3239929"/>
            <a:ext cx="2554418" cy="6002369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1A41E-53F2-400E-ADFE-67706180A4D3}" type="datetimeFigureOut">
              <a:rPr kumimoji="1" lang="ja-JP" altLang="en-US" smtClean="0"/>
              <a:t>2024/3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2ECE2-64B9-412A-81B2-A51B10537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6986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719984"/>
            <a:ext cx="2554418" cy="2519945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1554968"/>
            <a:ext cx="4009519" cy="7674832"/>
          </a:xfrm>
        </p:spPr>
        <p:txBody>
          <a:bodyPr anchor="t"/>
          <a:lstStyle>
            <a:lvl1pPr marL="0" indent="0">
              <a:buNone/>
              <a:defRPr sz="2772"/>
            </a:lvl1pPr>
            <a:lvl2pPr marL="395981" indent="0">
              <a:buNone/>
              <a:defRPr sz="2425"/>
            </a:lvl2pPr>
            <a:lvl3pPr marL="791962" indent="0">
              <a:buNone/>
              <a:defRPr sz="2079"/>
            </a:lvl3pPr>
            <a:lvl4pPr marL="1187943" indent="0">
              <a:buNone/>
              <a:defRPr sz="1732"/>
            </a:lvl4pPr>
            <a:lvl5pPr marL="1583924" indent="0">
              <a:buNone/>
              <a:defRPr sz="1732"/>
            </a:lvl5pPr>
            <a:lvl6pPr marL="1979905" indent="0">
              <a:buNone/>
              <a:defRPr sz="1732"/>
            </a:lvl6pPr>
            <a:lvl7pPr marL="2375886" indent="0">
              <a:buNone/>
              <a:defRPr sz="1732"/>
            </a:lvl7pPr>
            <a:lvl8pPr marL="2771866" indent="0">
              <a:buNone/>
              <a:defRPr sz="1732"/>
            </a:lvl8pPr>
            <a:lvl9pPr marL="3167847" indent="0">
              <a:buNone/>
              <a:defRPr sz="1732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3239929"/>
            <a:ext cx="2554418" cy="6002369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1A41E-53F2-400E-ADFE-67706180A4D3}" type="datetimeFigureOut">
              <a:rPr kumimoji="1" lang="ja-JP" altLang="en-US" smtClean="0"/>
              <a:t>2024/3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2ECE2-64B9-412A-81B2-A51B10537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3286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574990"/>
            <a:ext cx="6831033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2874937"/>
            <a:ext cx="6831033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10009783"/>
            <a:ext cx="1782009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81A41E-53F2-400E-ADFE-67706180A4D3}" type="datetimeFigureOut">
              <a:rPr kumimoji="1" lang="ja-JP" altLang="en-US" smtClean="0"/>
              <a:t>2024/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10009783"/>
            <a:ext cx="2673013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10009783"/>
            <a:ext cx="1782009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12ECE2-64B9-412A-81B2-A51B105373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812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91962" rtl="0" eaLnBrk="1" latinLnBrk="0" hangingPunct="1">
        <a:lnSpc>
          <a:spcPct val="90000"/>
        </a:lnSpc>
        <a:spcBef>
          <a:spcPct val="0"/>
        </a:spcBef>
        <a:buNone/>
        <a:defRPr kumimoji="1" sz="38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7990" indent="-197990" algn="l" defTabSz="791962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kumimoji="1" sz="2425" kern="1200">
          <a:solidFill>
            <a:schemeClr val="tx1"/>
          </a:solidFill>
          <a:latin typeface="+mn-lt"/>
          <a:ea typeface="+mn-ea"/>
          <a:cs typeface="+mn-cs"/>
        </a:defRPr>
      </a:lvl1pPr>
      <a:lvl2pPr marL="593971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kumimoji="1"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989952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kumimoji="1" sz="1732" kern="1200">
          <a:solidFill>
            <a:schemeClr val="tx1"/>
          </a:solidFill>
          <a:latin typeface="+mn-lt"/>
          <a:ea typeface="+mn-ea"/>
          <a:cs typeface="+mn-cs"/>
        </a:defRPr>
      </a:lvl3pPr>
      <a:lvl4pPr marL="1385933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781914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2177895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573876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969857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365838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1962" rtl="0" eaLnBrk="1" latinLnBrk="0" hangingPunct="1"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1pPr>
      <a:lvl2pPr marL="395981" algn="l" defTabSz="791962" rtl="0" eaLnBrk="1" latinLnBrk="0" hangingPunct="1"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91962" algn="l" defTabSz="791962" rtl="0" eaLnBrk="1" latinLnBrk="0" hangingPunct="1"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3pPr>
      <a:lvl4pPr marL="1187943" algn="l" defTabSz="791962" rtl="0" eaLnBrk="1" latinLnBrk="0" hangingPunct="1"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583924" algn="l" defTabSz="791962" rtl="0" eaLnBrk="1" latinLnBrk="0" hangingPunct="1"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1979905" algn="l" defTabSz="791962" rtl="0" eaLnBrk="1" latinLnBrk="0" hangingPunct="1"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375886" algn="l" defTabSz="791962" rtl="0" eaLnBrk="1" latinLnBrk="0" hangingPunct="1"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771866" algn="l" defTabSz="791962" rtl="0" eaLnBrk="1" latinLnBrk="0" hangingPunct="1"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167847" algn="l" defTabSz="791962" rtl="0" eaLnBrk="1" latinLnBrk="0" hangingPunct="1"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B9C9E51-6851-4A6A-9CA7-A14552DCD1C7}"/>
              </a:ext>
            </a:extLst>
          </p:cNvPr>
          <p:cNvSpPr txBox="1"/>
          <p:nvPr/>
        </p:nvSpPr>
        <p:spPr>
          <a:xfrm>
            <a:off x="688116" y="227845"/>
            <a:ext cx="275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1C00208-7D12-1649-2D99-511617682965}"/>
              </a:ext>
            </a:extLst>
          </p:cNvPr>
          <p:cNvSpPr txBox="1"/>
          <p:nvPr/>
        </p:nvSpPr>
        <p:spPr>
          <a:xfrm>
            <a:off x="4116359" y="201366"/>
            <a:ext cx="275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BE52D60-4C83-D36A-1A04-71BBFE34CD36}"/>
              </a:ext>
            </a:extLst>
          </p:cNvPr>
          <p:cNvSpPr txBox="1"/>
          <p:nvPr/>
        </p:nvSpPr>
        <p:spPr>
          <a:xfrm>
            <a:off x="688116" y="2880639"/>
            <a:ext cx="275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9CCF890-8C07-FB53-E5A4-DDB8F3B0A020}"/>
              </a:ext>
            </a:extLst>
          </p:cNvPr>
          <p:cNvSpPr txBox="1"/>
          <p:nvPr/>
        </p:nvSpPr>
        <p:spPr>
          <a:xfrm>
            <a:off x="4157346" y="2880639"/>
            <a:ext cx="275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6BBE81A-7E04-1221-323B-46A231440DEE}"/>
              </a:ext>
            </a:extLst>
          </p:cNvPr>
          <p:cNvSpPr txBox="1"/>
          <p:nvPr/>
        </p:nvSpPr>
        <p:spPr>
          <a:xfrm>
            <a:off x="689205" y="5270349"/>
            <a:ext cx="275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6BE04F2-EB91-ECDE-583E-AE41EED1C20D}"/>
              </a:ext>
            </a:extLst>
          </p:cNvPr>
          <p:cNvSpPr txBox="1"/>
          <p:nvPr/>
        </p:nvSpPr>
        <p:spPr>
          <a:xfrm>
            <a:off x="4157346" y="5319700"/>
            <a:ext cx="275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D7A04C0-3F7B-0B93-DE99-887BCD4370DC}"/>
              </a:ext>
            </a:extLst>
          </p:cNvPr>
          <p:cNvSpPr txBox="1"/>
          <p:nvPr/>
        </p:nvSpPr>
        <p:spPr>
          <a:xfrm>
            <a:off x="733534" y="7810409"/>
            <a:ext cx="275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384D79A-1DE4-6B67-E221-EF10B1528F3D}"/>
              </a:ext>
            </a:extLst>
          </p:cNvPr>
          <p:cNvSpPr txBox="1"/>
          <p:nvPr/>
        </p:nvSpPr>
        <p:spPr>
          <a:xfrm>
            <a:off x="4152198" y="7825713"/>
            <a:ext cx="2280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5F5CC05E-580E-4BB2-9C4C-B415EE021E1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2275657"/>
              </p:ext>
            </p:extLst>
          </p:nvPr>
        </p:nvGraphicFramePr>
        <p:xfrm>
          <a:off x="694136" y="559947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CC2095E4-5862-4FBA-BB9F-45C672EA1F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0887425"/>
              </p:ext>
            </p:extLst>
          </p:nvPr>
        </p:nvGraphicFramePr>
        <p:xfrm>
          <a:off x="4084061" y="439837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BB73CD62-71BC-4F14-BD23-DCAD50D6500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5982664"/>
              </p:ext>
            </p:extLst>
          </p:nvPr>
        </p:nvGraphicFramePr>
        <p:xfrm>
          <a:off x="724524" y="3144328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50E0324A-DEAD-4BF2-95D3-F752904AD3A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9295199"/>
              </p:ext>
            </p:extLst>
          </p:nvPr>
        </p:nvGraphicFramePr>
        <p:xfrm>
          <a:off x="4110572" y="3160673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FB569E7F-84A1-45CE-9AF4-BFCFBC1023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3008293"/>
              </p:ext>
            </p:extLst>
          </p:nvPr>
        </p:nvGraphicFramePr>
        <p:xfrm>
          <a:off x="772061" y="5629980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136297FC-4EDF-41FB-81C8-CB0350623C2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28974639"/>
              </p:ext>
            </p:extLst>
          </p:nvPr>
        </p:nvGraphicFramePr>
        <p:xfrm>
          <a:off x="4078274" y="5650409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7" name="グラフ 26">
            <a:extLst>
              <a:ext uri="{FF2B5EF4-FFF2-40B4-BE49-F238E27FC236}">
                <a16:creationId xmlns:a16="http://schemas.microsoft.com/office/drawing/2014/main" id="{A09B2614-19CE-4FF1-9C8A-7588ED2249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8155560"/>
              </p:ext>
            </p:extLst>
          </p:nvPr>
        </p:nvGraphicFramePr>
        <p:xfrm>
          <a:off x="724524" y="8183876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8" name="グラフ 27">
            <a:extLst>
              <a:ext uri="{FF2B5EF4-FFF2-40B4-BE49-F238E27FC236}">
                <a16:creationId xmlns:a16="http://schemas.microsoft.com/office/drawing/2014/main" id="{63DBB5FC-2BC6-4273-AB63-D886DA3AC33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7242078"/>
              </p:ext>
            </p:extLst>
          </p:nvPr>
        </p:nvGraphicFramePr>
        <p:xfrm>
          <a:off x="4110572" y="8192881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C0690B7-94DB-6283-AB60-5F8A0437A169}"/>
              </a:ext>
            </a:extLst>
          </p:cNvPr>
          <p:cNvSpPr txBox="1"/>
          <p:nvPr/>
        </p:nvSpPr>
        <p:spPr>
          <a:xfrm rot="16200000">
            <a:off x="137853" y="1271774"/>
            <a:ext cx="99141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</a:rPr>
              <a:t>Incidence, %</a:t>
            </a:r>
            <a:endParaRPr lang="ja-JP" altLang="en-US" sz="12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C743E04-E616-33E0-18BC-EA9A487CA95E}"/>
              </a:ext>
            </a:extLst>
          </p:cNvPr>
          <p:cNvSpPr txBox="1"/>
          <p:nvPr/>
        </p:nvSpPr>
        <p:spPr>
          <a:xfrm>
            <a:off x="1589205" y="2650567"/>
            <a:ext cx="177536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5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</a:rPr>
              <a:t>No. of SMC applicable items</a:t>
            </a:r>
            <a:endParaRPr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217520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197D6F2-1226-C161-21B1-120D524FF4F3}"/>
              </a:ext>
            </a:extLst>
          </p:cNvPr>
          <p:cNvSpPr txBox="1"/>
          <p:nvPr/>
        </p:nvSpPr>
        <p:spPr>
          <a:xfrm>
            <a:off x="756545" y="566928"/>
            <a:ext cx="275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3F4B858-DD70-11AD-D360-E4C9DF23C71D}"/>
              </a:ext>
            </a:extLst>
          </p:cNvPr>
          <p:cNvSpPr txBox="1"/>
          <p:nvPr/>
        </p:nvSpPr>
        <p:spPr>
          <a:xfrm>
            <a:off x="4129224" y="566928"/>
            <a:ext cx="275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E6D9A36-E679-DF32-C66C-E19209B01BE6}"/>
              </a:ext>
            </a:extLst>
          </p:cNvPr>
          <p:cNvSpPr txBox="1"/>
          <p:nvPr/>
        </p:nvSpPr>
        <p:spPr>
          <a:xfrm>
            <a:off x="772632" y="3150157"/>
            <a:ext cx="275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5A0B2FB-05E9-840A-A6AA-9C45F4F6A916}"/>
              </a:ext>
            </a:extLst>
          </p:cNvPr>
          <p:cNvSpPr txBox="1"/>
          <p:nvPr/>
        </p:nvSpPr>
        <p:spPr>
          <a:xfrm>
            <a:off x="4145311" y="3150157"/>
            <a:ext cx="275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A255762-889C-2F37-367A-528763E581CB}"/>
              </a:ext>
            </a:extLst>
          </p:cNvPr>
          <p:cNvSpPr txBox="1"/>
          <p:nvPr/>
        </p:nvSpPr>
        <p:spPr>
          <a:xfrm>
            <a:off x="752287" y="5705737"/>
            <a:ext cx="6628261" cy="30469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28600" indent="-228600">
              <a:buFont typeface="+mj-lt"/>
              <a:buAutoNum type="alphaUcParenR"/>
            </a:pPr>
            <a:r>
              <a:rPr lang="en-US" altLang="ja-JP" sz="120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When going from a stop line, I almost hit someone coming from a different direction.</a:t>
            </a:r>
          </a:p>
          <a:p>
            <a:pPr marL="228600" indent="-228600">
              <a:buAutoNum type="alphaUcParenR"/>
            </a:pPr>
            <a:r>
              <a:rPr lang="en-US" altLang="ja-JP" sz="120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When attempting to turn right, I almost hit a car coming straight on.</a:t>
            </a:r>
          </a:p>
          <a:p>
            <a:pPr marL="228600" indent="-228600">
              <a:buAutoNum type="alphaUcParenR"/>
            </a:pPr>
            <a:r>
              <a:rPr lang="en-US" altLang="ja-JP" sz="120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When attempting to turn right, I </a:t>
            </a:r>
            <a:r>
              <a:rPr lang="en-US" altLang="ja-JP" sz="1200" kern="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almost hit a pedestrian or bicycle</a:t>
            </a:r>
          </a:p>
          <a:p>
            <a:pPr marL="228600" indent="-228600">
              <a:buAutoNum type="alphaUcParenR"/>
            </a:pPr>
            <a:r>
              <a:rPr lang="en-US" altLang="ja-JP" sz="1200" kern="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When attempting to turn left, I almost hit a pedestrian or bicycle</a:t>
            </a:r>
          </a:p>
          <a:p>
            <a:pPr marL="228600" indent="-228600">
              <a:buAutoNum type="alphaUcParenR"/>
            </a:pPr>
            <a:r>
              <a:rPr lang="en-US" altLang="ja-JP" sz="1200" kern="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I protruded greatly into the oncoming lane and almost collided head-on with another vehicle</a:t>
            </a:r>
          </a:p>
          <a:p>
            <a:pPr marL="228600" indent="-228600">
              <a:buAutoNum type="alphaUcParenR"/>
            </a:pPr>
            <a:r>
              <a:rPr lang="en-US" altLang="ja-JP" sz="1200" kern="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When changing lanes, I almost collided with another vehicle.</a:t>
            </a:r>
          </a:p>
          <a:p>
            <a:pPr marL="228600" indent="-228600">
              <a:buAutoNum type="alphaUcParenR"/>
            </a:pPr>
            <a:r>
              <a:rPr lang="en-US" altLang="ja-JP" sz="1200" kern="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I almost collided with a vehicle in front of me.</a:t>
            </a:r>
          </a:p>
          <a:p>
            <a:pPr marL="228600" indent="-228600">
              <a:buAutoNum type="alphaUcParenR"/>
            </a:pPr>
            <a:r>
              <a:rPr lang="en-US" altLang="ja-JP" sz="1200" kern="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I almost struck a bicycle, motorcycle, other vehicle I was overtaking or passing.</a:t>
            </a:r>
          </a:p>
          <a:p>
            <a:pPr marL="228600" indent="-228600">
              <a:buAutoNum type="alphaUcParenR"/>
            </a:pPr>
            <a:r>
              <a:rPr lang="en-US" altLang="ja-JP" sz="1200" kern="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I made a mistake while stepping on the accelerator or brake.</a:t>
            </a:r>
          </a:p>
          <a:p>
            <a:pPr marL="228600" indent="-228600">
              <a:buAutoNum type="alphaUcParenR"/>
            </a:pPr>
            <a:r>
              <a:rPr lang="en-US" altLang="ja-JP" sz="1200" kern="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When slope starting, I almost hit another vehicle or obstacle (including living things).</a:t>
            </a:r>
          </a:p>
          <a:p>
            <a:pPr marL="228600" indent="-228600">
              <a:buAutoNum type="alphaUcParenR"/>
            </a:pPr>
            <a:r>
              <a:rPr lang="en-US" altLang="ja-JP" sz="1200" kern="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When backing up to park, I almost hit another vehicle or obstacle (including living things).</a:t>
            </a:r>
          </a:p>
          <a:p>
            <a:pPr marL="228600" indent="-228600">
              <a:buAutoNum type="alphaUcParenR"/>
            </a:pPr>
            <a:r>
              <a:rPr lang="en-US" altLang="ja-JP" sz="1200" kern="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When I entered a store parking lot from the road, I almost ran up on the curb of the sidewalk.</a:t>
            </a:r>
          </a:p>
          <a:p>
            <a:endParaRPr lang="en-US" altLang="ja-JP" sz="1200" b="1" kern="0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  <a:p>
            <a:r>
              <a:rPr lang="en-US" altLang="ja-JP" sz="1200" b="1" kern="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Figure</a:t>
            </a:r>
            <a:r>
              <a:rPr lang="ja-JP" altLang="en-US" sz="1200" b="1" kern="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 </a:t>
            </a:r>
            <a:r>
              <a:rPr lang="en-US" altLang="ja-JP" sz="1200" b="1" kern="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A.1. </a:t>
            </a:r>
            <a:r>
              <a:rPr lang="en-US" altLang="ja-JP" sz="1200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Comparison of each near-miss traffic-incident item and the number of SMC items using the Cochran-Armitage trend test</a:t>
            </a:r>
            <a:r>
              <a:rPr lang="en-US" altLang="ja-JP" sz="1200" kern="10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. All comparisons showed P &lt; 0.001. </a:t>
            </a:r>
          </a:p>
          <a:p>
            <a:r>
              <a:rPr lang="en-US" altLang="ja-JP" sz="1200" kern="100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SMC, subjective memory concerns</a:t>
            </a:r>
          </a:p>
        </p:txBody>
      </p:sp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9D7174AC-162D-4ADF-82BB-6A17946561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3430542"/>
              </p:ext>
            </p:extLst>
          </p:nvPr>
        </p:nvGraphicFramePr>
        <p:xfrm>
          <a:off x="733857" y="955090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3498ED4C-4E99-4F09-830A-B51C7F6F471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9113913"/>
              </p:ext>
            </p:extLst>
          </p:nvPr>
        </p:nvGraphicFramePr>
        <p:xfrm>
          <a:off x="4102625" y="991764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8C5FC9A5-D55D-4620-9B14-0B37C42F74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941446"/>
              </p:ext>
            </p:extLst>
          </p:nvPr>
        </p:nvGraphicFramePr>
        <p:xfrm>
          <a:off x="733857" y="3459455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E07FC088-12D7-45E0-9D90-54A878FDBE5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6854999"/>
              </p:ext>
            </p:extLst>
          </p:nvPr>
        </p:nvGraphicFramePr>
        <p:xfrm>
          <a:off x="4066414" y="3470150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8308860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図 26">
            <a:extLst>
              <a:ext uri="{FF2B5EF4-FFF2-40B4-BE49-F238E27FC236}">
                <a16:creationId xmlns:a16="http://schemas.microsoft.com/office/drawing/2014/main" id="{3BBD5AB0-1D3B-08CC-584A-106C45C4DB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94925" y="7721080"/>
            <a:ext cx="3303406" cy="1980000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784E299A-12FD-AE08-3A9B-20D106FE21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0794" y="7721080"/>
            <a:ext cx="3303407" cy="198000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328E94D0-70DB-DE9D-FC30-6363E470D3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13918" y="5840856"/>
            <a:ext cx="3303406" cy="19800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A5EEAB6B-5700-12EA-AC7A-95A1CFA51E3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69620" y="5833427"/>
            <a:ext cx="3303406" cy="19800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A6502C18-CA69-87E0-2D2F-3906D54A5F6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10351" y="3950672"/>
            <a:ext cx="3303406" cy="19800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A1BB135C-A8EB-E2B8-686C-F3BE98AB702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79491" y="3950469"/>
            <a:ext cx="3303408" cy="1980000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16BDF9CB-1A2A-CC32-E2BE-ED9021769CA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94925" y="2059491"/>
            <a:ext cx="3303406" cy="198000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99035D62-ECF4-CF91-C7DF-D21DD646C86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86299" y="2059491"/>
            <a:ext cx="3303406" cy="19800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CEFCED9-093D-4B03-A103-F7FC397B50F8}"/>
              </a:ext>
            </a:extLst>
          </p:cNvPr>
          <p:cNvSpPr txBox="1"/>
          <p:nvPr/>
        </p:nvSpPr>
        <p:spPr>
          <a:xfrm>
            <a:off x="3302" y="9732505"/>
            <a:ext cx="791673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A.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dds ratios of interactions between the number of SMC applicable items and covariates with traffic incidents</a:t>
            </a:r>
          </a:p>
          <a:p>
            <a:r>
              <a:rPr lang="en-US" altLang="ja-JP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</a:rPr>
              <a:t>Adjusted for age, sex, educational year, eye diseases, hearing difficulty, medication use, sleep duration, EDS, </a:t>
            </a:r>
          </a:p>
          <a:p>
            <a:r>
              <a:rPr lang="en-US" altLang="ja-JP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游ゴシック" panose="020B0400000000000000" pitchFamily="50" charset="-128"/>
              </a:rPr>
              <a:t>driving time, and OCI.</a:t>
            </a:r>
          </a:p>
          <a:p>
            <a:r>
              <a:rPr lang="en-US" altLang="ja-JP" sz="1200" kern="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MC, subjective memory concerns; EDS, excessive daytime sleepiness; OCI, objective cognitive impairment; OR, odds ratios</a:t>
            </a: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6E4F740D-3FF6-4644-ED78-F78785854076}"/>
              </a:ext>
            </a:extLst>
          </p:cNvPr>
          <p:cNvSpPr/>
          <p:nvPr/>
        </p:nvSpPr>
        <p:spPr>
          <a:xfrm>
            <a:off x="3887480" y="176117"/>
            <a:ext cx="2001324" cy="26700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F7D4FAD9-3AB0-BAD8-3326-D75C839CFEC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10351" y="184093"/>
            <a:ext cx="3303406" cy="198000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A6BD167D-AC39-DDEA-B56A-88D00799553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779493" y="173766"/>
            <a:ext cx="3303406" cy="1980000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A8FFC8F-7D8E-3DB3-3BBA-EEC73ADA7B88}"/>
              </a:ext>
            </a:extLst>
          </p:cNvPr>
          <p:cNvSpPr txBox="1"/>
          <p:nvPr/>
        </p:nvSpPr>
        <p:spPr>
          <a:xfrm>
            <a:off x="1178854" y="247509"/>
            <a:ext cx="1171644" cy="171405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OCI:  0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1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2 items</a:t>
            </a:r>
          </a:p>
          <a:p>
            <a:pPr>
              <a:lnSpc>
                <a:spcPts val="1600"/>
              </a:lnSpc>
            </a:pPr>
            <a:r>
              <a: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≥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items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OCI:       0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1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2 items</a:t>
            </a:r>
          </a:p>
          <a:p>
            <a:pPr>
              <a:lnSpc>
                <a:spcPts val="1600"/>
              </a:lnSpc>
            </a:pPr>
            <a:r>
              <a: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≥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items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1FDDD1C-DC24-1891-9CD9-C288F24D668E}"/>
              </a:ext>
            </a:extLst>
          </p:cNvPr>
          <p:cNvSpPr txBox="1"/>
          <p:nvPr/>
        </p:nvSpPr>
        <p:spPr>
          <a:xfrm>
            <a:off x="2292987" y="2581"/>
            <a:ext cx="1207979" cy="27263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 collisions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F084688-0F2F-B009-AC10-3C816D4C2A74}"/>
              </a:ext>
            </a:extLst>
          </p:cNvPr>
          <p:cNvSpPr txBox="1"/>
          <p:nvPr/>
        </p:nvSpPr>
        <p:spPr>
          <a:xfrm>
            <a:off x="5037949" y="12769"/>
            <a:ext cx="2077635" cy="27263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ar-miss traffic incidents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2E7B6E5-5977-8C7B-422E-C377486D12A5}"/>
              </a:ext>
            </a:extLst>
          </p:cNvPr>
          <p:cNvSpPr txBox="1"/>
          <p:nvPr/>
        </p:nvSpPr>
        <p:spPr>
          <a:xfrm>
            <a:off x="763052" y="2130026"/>
            <a:ext cx="1644960" cy="171405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Without eye disease: 0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1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2 items</a:t>
            </a:r>
          </a:p>
          <a:p>
            <a:pPr>
              <a:lnSpc>
                <a:spcPts val="1600"/>
              </a:lnSpc>
            </a:pPr>
            <a:r>
              <a: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≥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items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With eye disease: 0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1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2 items</a:t>
            </a:r>
          </a:p>
          <a:p>
            <a:pPr>
              <a:lnSpc>
                <a:spcPts val="1600"/>
              </a:lnSpc>
            </a:pPr>
            <a:r>
              <a: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≥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items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3724C31-29A7-81E9-9C17-01DC892F0756}"/>
              </a:ext>
            </a:extLst>
          </p:cNvPr>
          <p:cNvSpPr txBox="1"/>
          <p:nvPr/>
        </p:nvSpPr>
        <p:spPr>
          <a:xfrm>
            <a:off x="384679" y="4016578"/>
            <a:ext cx="1960227" cy="171405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Without hearing difficulty: 0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1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2 items</a:t>
            </a:r>
          </a:p>
          <a:p>
            <a:pPr>
              <a:lnSpc>
                <a:spcPts val="1600"/>
              </a:lnSpc>
            </a:pPr>
            <a:r>
              <a: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≥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items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With hearing difficulty:     0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1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2 items</a:t>
            </a:r>
          </a:p>
          <a:p>
            <a:pPr>
              <a:lnSpc>
                <a:spcPts val="1600"/>
              </a:lnSpc>
            </a:pPr>
            <a:r>
              <a: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≥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items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284E35C-FE2A-B9D7-B6F2-01F8F2E12F61}"/>
              </a:ext>
            </a:extLst>
          </p:cNvPr>
          <p:cNvSpPr txBox="1"/>
          <p:nvPr/>
        </p:nvSpPr>
        <p:spPr>
          <a:xfrm>
            <a:off x="1116199" y="5923982"/>
            <a:ext cx="1233903" cy="171405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out EDS: 0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1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2 items</a:t>
            </a:r>
          </a:p>
          <a:p>
            <a:pPr>
              <a:lnSpc>
                <a:spcPts val="1600"/>
              </a:lnSpc>
            </a:pPr>
            <a:r>
              <a: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≥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items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EDS:        0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1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2 items</a:t>
            </a:r>
          </a:p>
          <a:p>
            <a:pPr>
              <a:lnSpc>
                <a:spcPts val="1600"/>
              </a:lnSpc>
            </a:pPr>
            <a:r>
              <a: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≥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items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A6A9DBC-EB71-99AE-CBCB-3FEEE0FC3F63}"/>
              </a:ext>
            </a:extLst>
          </p:cNvPr>
          <p:cNvSpPr txBox="1"/>
          <p:nvPr/>
        </p:nvSpPr>
        <p:spPr>
          <a:xfrm>
            <a:off x="334229" y="7804944"/>
            <a:ext cx="2022179" cy="171405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>
              <a:lnSpc>
                <a:spcPts val="1600"/>
              </a:lnSpc>
            </a:pPr>
            <a:r>
              <a: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≥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hours of sleep duration: 0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1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2 items</a:t>
            </a:r>
          </a:p>
          <a:p>
            <a:pPr>
              <a:lnSpc>
                <a:spcPts val="1600"/>
              </a:lnSpc>
            </a:pPr>
            <a:r>
              <a: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≥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items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&lt;6 hours of sleep duration: 0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1 item</a:t>
            </a:r>
          </a:p>
          <a:p>
            <a:pPr>
              <a:lnSpc>
                <a:spcPts val="1600"/>
              </a:lnSpc>
            </a:pP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2 items</a:t>
            </a:r>
          </a:p>
          <a:p>
            <a:pPr>
              <a:lnSpc>
                <a:spcPts val="1600"/>
              </a:lnSpc>
            </a:pPr>
            <a:r>
              <a:rPr kumimoji="1"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≥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items</a:t>
            </a: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5DDC0D60-612C-C728-153E-97F947D593E7}"/>
              </a:ext>
            </a:extLst>
          </p:cNvPr>
          <p:cNvSpPr/>
          <p:nvPr/>
        </p:nvSpPr>
        <p:spPr>
          <a:xfrm rot="5400000" flipV="1">
            <a:off x="4201127" y="3052845"/>
            <a:ext cx="178503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8A5B88E9-6A0A-141C-4217-C227B4101073}"/>
              </a:ext>
            </a:extLst>
          </p:cNvPr>
          <p:cNvSpPr/>
          <p:nvPr/>
        </p:nvSpPr>
        <p:spPr>
          <a:xfrm rot="5400000" flipV="1">
            <a:off x="4177550" y="8726113"/>
            <a:ext cx="178503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30ED65EE-A1B0-41FA-904F-EE607E981DB1}"/>
              </a:ext>
            </a:extLst>
          </p:cNvPr>
          <p:cNvSpPr/>
          <p:nvPr/>
        </p:nvSpPr>
        <p:spPr>
          <a:xfrm rot="5400000" flipV="1">
            <a:off x="4175446" y="6797469"/>
            <a:ext cx="178503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47831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66</TotalTime>
  <Words>480</Words>
  <Application>Microsoft Office PowerPoint</Application>
  <PresentationFormat>ユーザー設定</PresentationFormat>
  <Paragraphs>75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toshi Kurita</dc:creator>
  <cp:lastModifiedBy>Satoshi KURITA</cp:lastModifiedBy>
  <cp:revision>134</cp:revision>
  <dcterms:created xsi:type="dcterms:W3CDTF">2020-11-24T22:40:38Z</dcterms:created>
  <dcterms:modified xsi:type="dcterms:W3CDTF">2024-03-23T10:09:35Z</dcterms:modified>
</cp:coreProperties>
</file>